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sv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9" d="100"/>
          <a:sy n="89" d="100"/>
        </p:scale>
        <p:origin x="-1306" y="-67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36004" cy="36004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Rubrikbi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Underrubrik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sv-SE" smtClean="0"/>
              <a:t>Klicka här för att ändra format på underrubrik i bakgrunden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509ADD-DB25-40B3-B186-ECDA154D1F6A}" type="datetimeFigureOut">
              <a:rPr lang="sv-SE" smtClean="0"/>
              <a:t>2021-09-10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0DD2D0-DC1E-452B-9679-9CA60B99F12B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385869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Rubrik och lodrät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lodrät tex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509ADD-DB25-40B3-B186-ECDA154D1F6A}" type="datetimeFigureOut">
              <a:rPr lang="sv-SE" smtClean="0"/>
              <a:t>2021-09-10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0DD2D0-DC1E-452B-9679-9CA60B99F12B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8748113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ät rubrik och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ät rubrik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lodrät text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509ADD-DB25-40B3-B186-ECDA154D1F6A}" type="datetimeFigureOut">
              <a:rPr lang="sv-SE" smtClean="0"/>
              <a:t>2021-09-10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0DD2D0-DC1E-452B-9679-9CA60B99F12B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799780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Rubrik och innehål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innehåll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509ADD-DB25-40B3-B186-ECDA154D1F6A}" type="datetimeFigureOut">
              <a:rPr lang="sv-SE" smtClean="0"/>
              <a:t>2021-09-10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0DD2D0-DC1E-452B-9679-9CA60B99F12B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1029467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vsnitts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509ADD-DB25-40B3-B186-ECDA154D1F6A}" type="datetimeFigureOut">
              <a:rPr lang="sv-SE" smtClean="0"/>
              <a:t>2021-09-10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0DD2D0-DC1E-452B-9679-9CA60B99F12B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4460290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vå innehållsdela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innehåll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innehåll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509ADD-DB25-40B3-B186-ECDA154D1F6A}" type="datetimeFigureOut">
              <a:rPr lang="sv-SE" smtClean="0"/>
              <a:t>2021-09-10</a:t>
            </a:fld>
            <a:endParaRPr lang="sv-SE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0DD2D0-DC1E-452B-9679-9CA60B99F12B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0744132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Jämförels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4" name="Platshållare för innehåll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5" name="Platshållare för text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6" name="Platshållare för innehåll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7" name="Platshållare för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509ADD-DB25-40B3-B186-ECDA154D1F6A}" type="datetimeFigureOut">
              <a:rPr lang="sv-SE" smtClean="0"/>
              <a:t>2021-09-10</a:t>
            </a:fld>
            <a:endParaRPr lang="sv-SE"/>
          </a:p>
        </p:txBody>
      </p:sp>
      <p:sp>
        <p:nvSpPr>
          <p:cNvPr id="8" name="Platshållare för sidfo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9" name="Platshållare för bild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0DD2D0-DC1E-452B-9679-9CA60B99F12B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648985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Endast 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509ADD-DB25-40B3-B186-ECDA154D1F6A}" type="datetimeFigureOut">
              <a:rPr lang="sv-SE" smtClean="0"/>
              <a:t>2021-09-10</a:t>
            </a:fld>
            <a:endParaRPr lang="sv-SE"/>
          </a:p>
        </p:txBody>
      </p:sp>
      <p:sp>
        <p:nvSpPr>
          <p:cNvPr id="4" name="Platshållare för sidfo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5" name="Platshållare för bild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0DD2D0-DC1E-452B-9679-9CA60B99F12B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9308194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509ADD-DB25-40B3-B186-ECDA154D1F6A}" type="datetimeFigureOut">
              <a:rPr lang="sv-SE" smtClean="0"/>
              <a:t>2021-09-10</a:t>
            </a:fld>
            <a:endParaRPr lang="sv-SE"/>
          </a:p>
        </p:txBody>
      </p:sp>
      <p:sp>
        <p:nvSpPr>
          <p:cNvPr id="3" name="Platshållare för sidfo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Platshållare för bild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0DD2D0-DC1E-452B-9679-9CA60B99F12B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1263221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nehåll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innehåll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text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509ADD-DB25-40B3-B186-ECDA154D1F6A}" type="datetimeFigureOut">
              <a:rPr lang="sv-SE" smtClean="0"/>
              <a:t>2021-09-10</a:t>
            </a:fld>
            <a:endParaRPr lang="sv-SE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0DD2D0-DC1E-452B-9679-9CA60B99F12B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279422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bild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sv-SE"/>
          </a:p>
        </p:txBody>
      </p:sp>
      <p:sp>
        <p:nvSpPr>
          <p:cNvPr id="4" name="Platshållare för text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509ADD-DB25-40B3-B186-ECDA154D1F6A}" type="datetimeFigureOut">
              <a:rPr lang="sv-SE" smtClean="0"/>
              <a:t>2021-09-10</a:t>
            </a:fld>
            <a:endParaRPr lang="sv-SE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0DD2D0-DC1E-452B-9679-9CA60B99F12B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3346059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rubrik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509ADD-DB25-40B3-B186-ECDA154D1F6A}" type="datetimeFigureOut">
              <a:rPr lang="sv-SE" smtClean="0"/>
              <a:t>2021-09-10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0DD2D0-DC1E-452B-9679-9CA60B99F12B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7330728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ell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66362754"/>
              </p:ext>
            </p:extLst>
          </p:nvPr>
        </p:nvGraphicFramePr>
        <p:xfrm>
          <a:off x="863588" y="620688"/>
          <a:ext cx="7598236" cy="3521335"/>
        </p:xfrm>
        <a:graphic>
          <a:graphicData uri="http://schemas.openxmlformats.org/drawingml/2006/table">
            <a:tbl>
              <a:tblPr/>
              <a:tblGrid>
                <a:gridCol w="806008"/>
                <a:gridCol w="646879"/>
                <a:gridCol w="203297"/>
                <a:gridCol w="443582"/>
                <a:gridCol w="215626"/>
                <a:gridCol w="377346"/>
                <a:gridCol w="377346"/>
                <a:gridCol w="377346"/>
                <a:gridCol w="377346"/>
                <a:gridCol w="377346"/>
                <a:gridCol w="377346"/>
                <a:gridCol w="377346"/>
                <a:gridCol w="377346"/>
                <a:gridCol w="377346"/>
                <a:gridCol w="377346"/>
                <a:gridCol w="377346"/>
                <a:gridCol w="377346"/>
                <a:gridCol w="377346"/>
                <a:gridCol w="377346"/>
              </a:tblGrid>
              <a:tr h="34882">
                <a:tc gridSpan="19">
                  <a:txBody>
                    <a:bodyPr/>
                    <a:lstStyle/>
                    <a:p>
                      <a:pPr algn="l"/>
                      <a:r>
                        <a:rPr lang="sv-SE" sz="1200" dirty="0" err="1">
                          <a:effectLst/>
                        </a:rPr>
                        <a:t>Pearson's</a:t>
                      </a:r>
                      <a:r>
                        <a:rPr lang="sv-SE" sz="1200" dirty="0">
                          <a:effectLst/>
                        </a:rPr>
                        <a:t> </a:t>
                      </a:r>
                      <a:r>
                        <a:rPr lang="sv-SE" sz="1200" dirty="0" err="1">
                          <a:effectLst/>
                        </a:rPr>
                        <a:t>Correlations</a:t>
                      </a:r>
                      <a:r>
                        <a:rPr lang="sv-SE" sz="1200" dirty="0">
                          <a:effectLst/>
                        </a:rPr>
                        <a:t> </a:t>
                      </a:r>
                      <a:r>
                        <a:rPr lang="sv-SE" sz="1200" dirty="0" smtClean="0">
                          <a:effectLst/>
                        </a:rPr>
                        <a:t>(N=31)</a:t>
                      </a:r>
                      <a:endParaRPr lang="sv-SE" sz="1200" dirty="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</a:tr>
              <a:tr h="61044">
                <a:tc>
                  <a:txBody>
                    <a:bodyPr/>
                    <a:lstStyle/>
                    <a:p>
                      <a:pPr algn="ctr"/>
                      <a:r>
                        <a:rPr lang="sv-SE" sz="1200" dirty="0" err="1">
                          <a:effectLst/>
                        </a:rPr>
                        <a:t>Variable</a:t>
                      </a:r>
                      <a:r>
                        <a:rPr lang="sv-SE" sz="1200" dirty="0">
                          <a:effectLst/>
                        </a:rPr>
                        <a:t> </a:t>
                      </a: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sv-SE" sz="1200" dirty="0">
                          <a:effectLst/>
                        </a:rPr>
                        <a:t>Big5O </a:t>
                      </a: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sv-SE" sz="1200">
                          <a:effectLst/>
                        </a:rPr>
                        <a:t>Big5C </a:t>
                      </a: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sv-SE" sz="1200">
                          <a:effectLst/>
                        </a:rPr>
                        <a:t>Big5E </a:t>
                      </a: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sv-SE" sz="1200">
                          <a:effectLst/>
                        </a:rPr>
                        <a:t>Big5A </a:t>
                      </a: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sv-SE" sz="1200" dirty="0">
                          <a:effectLst/>
                        </a:rPr>
                        <a:t>Big5N </a:t>
                      </a: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sv-SE" sz="1200" dirty="0" smtClean="0">
                          <a:effectLst/>
                        </a:rPr>
                        <a:t>AQ</a:t>
                      </a:r>
                      <a:endParaRPr lang="sv-SE" sz="1200" dirty="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sv-SE" sz="1200" dirty="0" err="1" smtClean="0">
                          <a:effectLst/>
                        </a:rPr>
                        <a:t>Imagery</a:t>
                      </a:r>
                      <a:r>
                        <a:rPr lang="sv-SE" sz="1200" dirty="0" smtClean="0">
                          <a:effectLst/>
                        </a:rPr>
                        <a:t> </a:t>
                      </a:r>
                      <a:r>
                        <a:rPr lang="sv-SE" sz="1200" dirty="0" err="1" smtClean="0">
                          <a:effectLst/>
                        </a:rPr>
                        <a:t>obj</a:t>
                      </a:r>
                      <a:r>
                        <a:rPr lang="sv-SE" sz="1200" dirty="0" smtClean="0">
                          <a:effectLst/>
                        </a:rPr>
                        <a:t> </a:t>
                      </a:r>
                      <a:endParaRPr lang="sv-SE" sz="1200" dirty="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sv-SE" sz="1200" dirty="0" err="1" smtClean="0">
                          <a:effectLst/>
                        </a:rPr>
                        <a:t>Imagery</a:t>
                      </a:r>
                      <a:r>
                        <a:rPr lang="sv-SE" sz="1200" dirty="0" smtClean="0">
                          <a:effectLst/>
                        </a:rPr>
                        <a:t> spat </a:t>
                      </a:r>
                      <a:endParaRPr lang="sv-SE" sz="1200" dirty="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sv-SE" sz="1200" dirty="0" err="1" smtClean="0">
                          <a:effectLst/>
                        </a:rPr>
                        <a:t>Experiental</a:t>
                      </a:r>
                      <a:r>
                        <a:rPr lang="sv-SE" sz="1200" dirty="0" smtClean="0">
                          <a:effectLst/>
                        </a:rPr>
                        <a:t> </a:t>
                      </a:r>
                      <a:endParaRPr lang="sv-SE" sz="1200" dirty="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</a:tr>
              <a:tr h="244175">
                <a:tc>
                  <a:txBody>
                    <a:bodyPr/>
                    <a:lstStyle/>
                    <a:p>
                      <a:pPr algn="l"/>
                      <a:r>
                        <a:rPr lang="sv-SE" sz="1200" dirty="0" smtClean="0">
                          <a:effectLst/>
                        </a:rPr>
                        <a:t>Big5O </a:t>
                      </a:r>
                      <a:endParaRPr lang="sv-SE" sz="1200" dirty="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sv-SE" sz="1200" dirty="0">
                          <a:effectLst/>
                        </a:rPr>
                        <a:t>— </a:t>
                      </a: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sv-SE" sz="1200" dirty="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endParaRPr lang="sv-SE" sz="1200" dirty="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44175">
                <a:tc>
                  <a:txBody>
                    <a:bodyPr/>
                    <a:lstStyle/>
                    <a:p>
                      <a:pPr algn="l"/>
                      <a:r>
                        <a:rPr lang="sv-SE" sz="1200" dirty="0" smtClean="0">
                          <a:effectLst/>
                        </a:rPr>
                        <a:t>Big5C </a:t>
                      </a:r>
                      <a:endParaRPr lang="sv-SE" sz="1200" dirty="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sv-SE" sz="1200" dirty="0">
                          <a:effectLst/>
                        </a:rPr>
                        <a:t>-</a:t>
                      </a:r>
                      <a:r>
                        <a:rPr lang="sv-SE" sz="1200" dirty="0" smtClean="0">
                          <a:effectLst/>
                        </a:rPr>
                        <a:t>0.18</a:t>
                      </a:r>
                      <a:endParaRPr lang="sv-SE" sz="1200" dirty="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sv-SE" sz="1200">
                          <a:effectLst/>
                        </a:rPr>
                        <a:t>— </a:t>
                      </a: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endParaRPr lang="sv-SE" sz="1200" dirty="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endParaRPr lang="sv-SE" sz="1200" dirty="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sv-SE" sz="1200" dirty="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4175">
                <a:tc>
                  <a:txBody>
                    <a:bodyPr/>
                    <a:lstStyle/>
                    <a:p>
                      <a:pPr algn="l"/>
                      <a:r>
                        <a:rPr lang="sv-SE" sz="1200" dirty="0" smtClean="0">
                          <a:effectLst/>
                        </a:rPr>
                        <a:t>Big5E </a:t>
                      </a:r>
                      <a:endParaRPr lang="sv-SE" sz="1200" dirty="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sv-SE" sz="1200" dirty="0" smtClean="0">
                          <a:effectLst/>
                        </a:rPr>
                        <a:t>0.15 </a:t>
                      </a:r>
                      <a:endParaRPr lang="sv-SE" sz="1200" dirty="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sv-SE" sz="1200" dirty="0" smtClean="0">
                          <a:effectLst/>
                        </a:rPr>
                        <a:t>0.08 </a:t>
                      </a:r>
                      <a:endParaRPr lang="sv-SE" sz="1200" dirty="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sv-SE" sz="1200">
                          <a:effectLst/>
                        </a:rPr>
                        <a:t>— </a:t>
                      </a: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sv-SE" sz="1200" dirty="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sv-SE" sz="1200" dirty="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endParaRPr lang="sv-SE" sz="1200" dirty="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4175">
                <a:tc>
                  <a:txBody>
                    <a:bodyPr/>
                    <a:lstStyle/>
                    <a:p>
                      <a:pPr algn="l"/>
                      <a:r>
                        <a:rPr lang="sv-SE" sz="1200" dirty="0" smtClean="0">
                          <a:effectLst/>
                        </a:rPr>
                        <a:t>Big5A </a:t>
                      </a:r>
                      <a:endParaRPr lang="sv-SE" sz="1200" dirty="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sv-SE" sz="1200" dirty="0">
                          <a:effectLst/>
                        </a:rPr>
                        <a:t>-</a:t>
                      </a:r>
                      <a:r>
                        <a:rPr lang="sv-SE" sz="1200" dirty="0" smtClean="0">
                          <a:effectLst/>
                        </a:rPr>
                        <a:t>0.06 </a:t>
                      </a:r>
                      <a:endParaRPr lang="sv-SE" sz="1200" dirty="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sv-SE" sz="1200" dirty="0" smtClean="0">
                          <a:effectLst/>
                        </a:rPr>
                        <a:t>0.30</a:t>
                      </a:r>
                      <a:endParaRPr lang="sv-SE" sz="1200" dirty="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sv-SE" sz="1200" dirty="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sv-SE" sz="1200" dirty="0" smtClean="0">
                          <a:effectLst/>
                        </a:rPr>
                        <a:t>0.03 </a:t>
                      </a:r>
                      <a:endParaRPr lang="sv-SE" sz="1200" dirty="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sv-SE" sz="1200">
                          <a:effectLst/>
                        </a:rPr>
                        <a:t>— </a:t>
                      </a: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sv-SE" sz="1200" dirty="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endParaRPr lang="sv-SE" sz="1200" dirty="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4175">
                <a:tc>
                  <a:txBody>
                    <a:bodyPr/>
                    <a:lstStyle/>
                    <a:p>
                      <a:pPr algn="l"/>
                      <a:r>
                        <a:rPr lang="sv-SE" sz="1200" dirty="0" smtClean="0">
                          <a:effectLst/>
                        </a:rPr>
                        <a:t>Big5N </a:t>
                      </a:r>
                      <a:endParaRPr lang="sv-SE" sz="1200" dirty="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sv-SE" sz="1200" dirty="0" smtClean="0">
                          <a:effectLst/>
                        </a:rPr>
                        <a:t>0.40 </a:t>
                      </a:r>
                      <a:endParaRPr lang="sv-SE" sz="1200" dirty="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sv-SE" sz="1200" dirty="0">
                          <a:effectLst/>
                        </a:rPr>
                        <a:t>* </a:t>
                      </a: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sv-SE" sz="1200" dirty="0">
                          <a:effectLst/>
                        </a:rPr>
                        <a:t>-</a:t>
                      </a:r>
                      <a:r>
                        <a:rPr lang="sv-SE" sz="1200" dirty="0" smtClean="0">
                          <a:effectLst/>
                        </a:rPr>
                        <a:t>0.37</a:t>
                      </a:r>
                      <a:endParaRPr lang="sv-SE" sz="1200" dirty="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sv-SE" sz="1200">
                          <a:effectLst/>
                        </a:rPr>
                        <a:t>* </a:t>
                      </a: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sv-SE" sz="1200" dirty="0">
                          <a:effectLst/>
                        </a:rPr>
                        <a:t>-</a:t>
                      </a:r>
                      <a:r>
                        <a:rPr lang="sv-SE" sz="1200" dirty="0" smtClean="0">
                          <a:effectLst/>
                        </a:rPr>
                        <a:t>0.07 </a:t>
                      </a:r>
                      <a:endParaRPr lang="sv-SE" sz="1200" dirty="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sv-SE" sz="1200" dirty="0">
                          <a:effectLst/>
                        </a:rPr>
                        <a:t>-</a:t>
                      </a:r>
                      <a:r>
                        <a:rPr lang="sv-SE" sz="1200" dirty="0" smtClean="0">
                          <a:effectLst/>
                        </a:rPr>
                        <a:t>0.23 </a:t>
                      </a:r>
                      <a:endParaRPr lang="sv-SE" sz="1200" dirty="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sv-SE" sz="1200">
                          <a:effectLst/>
                        </a:rPr>
                        <a:t>— </a:t>
                      </a: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sv-SE" sz="1200" dirty="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4175">
                <a:tc>
                  <a:txBody>
                    <a:bodyPr/>
                    <a:lstStyle/>
                    <a:p>
                      <a:pPr algn="l"/>
                      <a:r>
                        <a:rPr lang="sv-SE" sz="1200" dirty="0" smtClean="0">
                          <a:effectLst/>
                        </a:rPr>
                        <a:t>AQ</a:t>
                      </a:r>
                      <a:endParaRPr lang="sv-SE" sz="1200" dirty="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sv-SE" sz="1200" dirty="0" smtClean="0">
                          <a:effectLst/>
                        </a:rPr>
                        <a:t>0.34</a:t>
                      </a:r>
                      <a:endParaRPr lang="sv-SE" sz="1200" dirty="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sv-SE" sz="1200" dirty="0">
                          <a:effectLst/>
                        </a:rPr>
                        <a:t>-</a:t>
                      </a:r>
                      <a:r>
                        <a:rPr lang="sv-SE" sz="1200" dirty="0" smtClean="0">
                          <a:effectLst/>
                        </a:rPr>
                        <a:t>0.32 </a:t>
                      </a:r>
                      <a:endParaRPr lang="sv-SE" sz="1200" dirty="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sv-SE" sz="1200" dirty="0">
                          <a:effectLst/>
                        </a:rPr>
                        <a:t>-</a:t>
                      </a:r>
                      <a:r>
                        <a:rPr lang="sv-SE" sz="1200" dirty="0" smtClean="0">
                          <a:effectLst/>
                        </a:rPr>
                        <a:t>0.05 </a:t>
                      </a:r>
                      <a:endParaRPr lang="sv-SE" sz="1200" dirty="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sv-SE" sz="1200" dirty="0">
                          <a:effectLst/>
                        </a:rPr>
                        <a:t>-</a:t>
                      </a:r>
                      <a:r>
                        <a:rPr lang="sv-SE" sz="1200" dirty="0" smtClean="0">
                          <a:effectLst/>
                        </a:rPr>
                        <a:t>0.56 </a:t>
                      </a:r>
                      <a:endParaRPr lang="sv-SE" sz="1200" dirty="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sv-SE" sz="1200" dirty="0">
                          <a:effectLst/>
                        </a:rPr>
                        <a:t>*** </a:t>
                      </a: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sv-SE" sz="1200" dirty="0" smtClean="0">
                          <a:effectLst/>
                        </a:rPr>
                        <a:t>0.50 </a:t>
                      </a:r>
                      <a:endParaRPr lang="sv-SE" sz="1200" dirty="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sv-SE" sz="1200" dirty="0">
                          <a:effectLst/>
                        </a:rPr>
                        <a:t>** </a:t>
                      </a: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sv-SE" sz="1200">
                          <a:effectLst/>
                        </a:rPr>
                        <a:t>— </a:t>
                      </a: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4175">
                <a:tc>
                  <a:txBody>
                    <a:bodyPr/>
                    <a:lstStyle/>
                    <a:p>
                      <a:pPr algn="l"/>
                      <a:r>
                        <a:rPr lang="sv-SE" sz="1200" dirty="0" err="1" smtClean="0">
                          <a:effectLst/>
                        </a:rPr>
                        <a:t>Imagery</a:t>
                      </a:r>
                      <a:r>
                        <a:rPr lang="sv-SE" sz="1200" baseline="0" dirty="0" smtClean="0">
                          <a:effectLst/>
                        </a:rPr>
                        <a:t> </a:t>
                      </a:r>
                      <a:r>
                        <a:rPr lang="sv-SE" sz="1200" dirty="0" smtClean="0">
                          <a:effectLst/>
                        </a:rPr>
                        <a:t> </a:t>
                      </a:r>
                      <a:r>
                        <a:rPr lang="sv-SE" sz="1200" dirty="0" err="1" smtClean="0">
                          <a:effectLst/>
                        </a:rPr>
                        <a:t>obj</a:t>
                      </a:r>
                      <a:r>
                        <a:rPr lang="sv-SE" sz="1200" dirty="0" smtClean="0">
                          <a:effectLst/>
                        </a:rPr>
                        <a:t> </a:t>
                      </a:r>
                      <a:endParaRPr lang="sv-SE" sz="1200" dirty="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sv-SE" sz="1200" dirty="0" smtClean="0">
                          <a:effectLst/>
                        </a:rPr>
                        <a:t>0.30 </a:t>
                      </a:r>
                      <a:endParaRPr lang="sv-SE" sz="1200" dirty="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sv-SE" sz="1200" dirty="0">
                          <a:effectLst/>
                        </a:rPr>
                        <a:t>-</a:t>
                      </a:r>
                      <a:r>
                        <a:rPr lang="sv-SE" sz="1200" dirty="0" smtClean="0">
                          <a:effectLst/>
                        </a:rPr>
                        <a:t>0.17 </a:t>
                      </a:r>
                      <a:endParaRPr lang="sv-SE" sz="1200" dirty="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sv-SE" sz="1200" dirty="0">
                          <a:effectLst/>
                        </a:rPr>
                        <a:t>-</a:t>
                      </a:r>
                      <a:r>
                        <a:rPr lang="sv-SE" sz="1200" dirty="0" smtClean="0">
                          <a:effectLst/>
                        </a:rPr>
                        <a:t>0.11 </a:t>
                      </a:r>
                      <a:endParaRPr lang="sv-SE" sz="1200" dirty="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sv-SE" sz="1200" dirty="0">
                          <a:effectLst/>
                        </a:rPr>
                        <a:t>-</a:t>
                      </a:r>
                      <a:r>
                        <a:rPr lang="sv-SE" sz="1200" dirty="0" smtClean="0">
                          <a:effectLst/>
                        </a:rPr>
                        <a:t>0.04 </a:t>
                      </a:r>
                      <a:endParaRPr lang="sv-SE" sz="1200" dirty="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sv-SE" sz="1200" dirty="0">
                          <a:effectLst/>
                        </a:rPr>
                        <a:t>-</a:t>
                      </a:r>
                      <a:r>
                        <a:rPr lang="sv-SE" sz="1200" dirty="0" smtClean="0">
                          <a:effectLst/>
                        </a:rPr>
                        <a:t>0.09 </a:t>
                      </a:r>
                      <a:endParaRPr lang="sv-SE" sz="1200" dirty="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sv-SE" sz="1200" dirty="0">
                          <a:effectLst/>
                        </a:rPr>
                        <a:t>-</a:t>
                      </a:r>
                      <a:r>
                        <a:rPr lang="sv-SE" sz="1200" dirty="0" smtClean="0">
                          <a:effectLst/>
                        </a:rPr>
                        <a:t>0.08 </a:t>
                      </a:r>
                      <a:endParaRPr lang="sv-SE" sz="1200" dirty="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sv-SE" sz="1200">
                          <a:effectLst/>
                        </a:rPr>
                        <a:t>— </a:t>
                      </a: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sv-SE" sz="1200" dirty="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4175">
                <a:tc>
                  <a:txBody>
                    <a:bodyPr/>
                    <a:lstStyle/>
                    <a:p>
                      <a:pPr algn="l"/>
                      <a:r>
                        <a:rPr lang="sv-SE" sz="1200" dirty="0" err="1" smtClean="0">
                          <a:effectLst/>
                        </a:rPr>
                        <a:t>Imagery</a:t>
                      </a:r>
                      <a:r>
                        <a:rPr lang="sv-SE" sz="1200" baseline="0" dirty="0" smtClean="0">
                          <a:effectLst/>
                        </a:rPr>
                        <a:t> spat</a:t>
                      </a:r>
                      <a:r>
                        <a:rPr lang="sv-SE" sz="1200" dirty="0" smtClean="0">
                          <a:effectLst/>
                        </a:rPr>
                        <a:t> </a:t>
                      </a:r>
                      <a:endParaRPr lang="sv-SE" sz="1200" dirty="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sv-SE" sz="1200" dirty="0" smtClean="0">
                          <a:effectLst/>
                        </a:rPr>
                        <a:t>0.08</a:t>
                      </a:r>
                      <a:endParaRPr lang="sv-SE" sz="1200" dirty="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sv-SE" sz="1200" dirty="0">
                          <a:effectLst/>
                        </a:rPr>
                        <a:t>-</a:t>
                      </a:r>
                      <a:r>
                        <a:rPr lang="sv-SE" sz="1200" dirty="0" smtClean="0">
                          <a:effectLst/>
                        </a:rPr>
                        <a:t>0.05 </a:t>
                      </a:r>
                      <a:endParaRPr lang="sv-SE" sz="1200" dirty="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sv-SE" sz="1200" dirty="0" smtClean="0">
                          <a:effectLst/>
                        </a:rPr>
                        <a:t>0.27 </a:t>
                      </a:r>
                      <a:endParaRPr lang="sv-SE" sz="1200" dirty="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sv-SE" sz="1200">
                          <a:effectLst/>
                        </a:rPr>
                        <a:t>0.050 </a:t>
                      </a: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sv-SE" sz="1200" dirty="0">
                          <a:effectLst/>
                        </a:rPr>
                        <a:t>-</a:t>
                      </a:r>
                      <a:r>
                        <a:rPr lang="sv-SE" sz="1200" dirty="0" smtClean="0">
                          <a:effectLst/>
                        </a:rPr>
                        <a:t>0.08 </a:t>
                      </a:r>
                      <a:endParaRPr lang="sv-SE" sz="1200" dirty="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sv-SE" sz="1200" dirty="0">
                          <a:effectLst/>
                        </a:rPr>
                        <a:t>-</a:t>
                      </a:r>
                      <a:r>
                        <a:rPr lang="sv-SE" sz="1200" dirty="0" smtClean="0">
                          <a:effectLst/>
                        </a:rPr>
                        <a:t>0.01 </a:t>
                      </a:r>
                      <a:endParaRPr lang="sv-SE" sz="1200" dirty="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sv-SE" sz="1200" dirty="0" smtClean="0">
                          <a:effectLst/>
                        </a:rPr>
                        <a:t>0.22 </a:t>
                      </a:r>
                      <a:endParaRPr lang="sv-SE" sz="1200" dirty="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sv-SE" sz="1200">
                          <a:effectLst/>
                        </a:rPr>
                        <a:t>— </a:t>
                      </a: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4175">
                <a:tc>
                  <a:txBody>
                    <a:bodyPr/>
                    <a:lstStyle/>
                    <a:p>
                      <a:pPr algn="l"/>
                      <a:r>
                        <a:rPr lang="sv-SE" sz="1200" dirty="0" err="1" smtClean="0">
                          <a:effectLst/>
                        </a:rPr>
                        <a:t>Experiental</a:t>
                      </a:r>
                      <a:r>
                        <a:rPr lang="sv-SE" sz="1200" dirty="0" smtClean="0">
                          <a:effectLst/>
                        </a:rPr>
                        <a:t> </a:t>
                      </a:r>
                      <a:endParaRPr lang="sv-SE" sz="1200" dirty="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sv-SE" sz="1200" dirty="0" smtClean="0">
                          <a:effectLst/>
                        </a:rPr>
                        <a:t>0.13 </a:t>
                      </a:r>
                      <a:endParaRPr lang="sv-SE" sz="1200" dirty="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sv-SE" sz="1200" dirty="0">
                          <a:effectLst/>
                        </a:rPr>
                        <a:t>-</a:t>
                      </a:r>
                      <a:r>
                        <a:rPr lang="sv-SE" sz="1200" dirty="0" smtClean="0">
                          <a:effectLst/>
                        </a:rPr>
                        <a:t>0.06 </a:t>
                      </a:r>
                      <a:endParaRPr lang="sv-SE" sz="1200" dirty="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sv-SE" sz="1200" dirty="0" smtClean="0">
                          <a:effectLst/>
                        </a:rPr>
                        <a:t>0.28 </a:t>
                      </a:r>
                      <a:endParaRPr lang="sv-SE" sz="1200" dirty="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sv-SE" sz="1200" dirty="0">
                          <a:effectLst/>
                        </a:rPr>
                        <a:t>-</a:t>
                      </a:r>
                      <a:r>
                        <a:rPr lang="sv-SE" sz="1200" dirty="0" smtClean="0">
                          <a:effectLst/>
                        </a:rPr>
                        <a:t>0.21 </a:t>
                      </a:r>
                      <a:endParaRPr lang="sv-SE" sz="1200" dirty="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sv-SE" sz="1200" dirty="0">
                          <a:effectLst/>
                        </a:rPr>
                        <a:t>-</a:t>
                      </a:r>
                      <a:r>
                        <a:rPr lang="sv-SE" sz="1200" dirty="0" smtClean="0">
                          <a:effectLst/>
                        </a:rPr>
                        <a:t>0.11 </a:t>
                      </a:r>
                      <a:endParaRPr lang="sv-SE" sz="1200" dirty="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sv-SE" sz="1200" dirty="0" smtClean="0">
                          <a:effectLst/>
                        </a:rPr>
                        <a:t>0.08 </a:t>
                      </a:r>
                      <a:endParaRPr lang="sv-SE" sz="1200" dirty="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sv-SE" sz="1200" dirty="0" smtClean="0">
                          <a:effectLst/>
                        </a:rPr>
                        <a:t>0.03 </a:t>
                      </a:r>
                      <a:endParaRPr lang="sv-SE" sz="1200" dirty="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sv-SE" sz="1200" dirty="0">
                          <a:effectLst/>
                        </a:rPr>
                        <a:t>-</a:t>
                      </a:r>
                      <a:r>
                        <a:rPr lang="sv-SE" sz="1200" dirty="0" smtClean="0">
                          <a:effectLst/>
                        </a:rPr>
                        <a:t>0.05 </a:t>
                      </a:r>
                      <a:endParaRPr lang="sv-SE" sz="1200" dirty="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sv-SE" sz="1200">
                          <a:effectLst/>
                        </a:rPr>
                        <a:t>— </a:t>
                      </a: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4175">
                <a:tc>
                  <a:txBody>
                    <a:bodyPr/>
                    <a:lstStyle/>
                    <a:p>
                      <a:pPr algn="l"/>
                      <a:r>
                        <a:rPr lang="sv-SE" sz="1200" dirty="0" err="1" smtClean="0">
                          <a:effectLst/>
                        </a:rPr>
                        <a:t>Rational</a:t>
                      </a:r>
                      <a:r>
                        <a:rPr lang="sv-SE" sz="1200" dirty="0" smtClean="0">
                          <a:effectLst/>
                        </a:rPr>
                        <a:t> </a:t>
                      </a:r>
                      <a:endParaRPr lang="sv-SE" sz="1200" dirty="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sv-SE" sz="1200" dirty="0" smtClean="0">
                          <a:effectLst/>
                        </a:rPr>
                        <a:t>0.32</a:t>
                      </a:r>
                      <a:endParaRPr lang="sv-SE" sz="1200" dirty="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sv-SE" sz="1200" dirty="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sv-SE" sz="1200" dirty="0">
                          <a:effectLst/>
                        </a:rPr>
                        <a:t>-</a:t>
                      </a:r>
                      <a:r>
                        <a:rPr lang="sv-SE" sz="1200" dirty="0" smtClean="0">
                          <a:effectLst/>
                        </a:rPr>
                        <a:t>0.05 </a:t>
                      </a:r>
                      <a:endParaRPr lang="sv-SE" sz="1200" dirty="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sv-SE" sz="1200" dirty="0">
                          <a:effectLst/>
                        </a:rPr>
                        <a:t>-</a:t>
                      </a:r>
                      <a:r>
                        <a:rPr lang="sv-SE" sz="1200" dirty="0" smtClean="0">
                          <a:effectLst/>
                        </a:rPr>
                        <a:t>0.14 </a:t>
                      </a:r>
                      <a:endParaRPr lang="sv-SE" sz="1200" dirty="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sv-SE" sz="1200">
                          <a:effectLst/>
                        </a:rPr>
                        <a:t>0.148 </a:t>
                      </a: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sv-SE" sz="1200" dirty="0">
                          <a:effectLst/>
                        </a:rPr>
                        <a:t>-</a:t>
                      </a:r>
                      <a:r>
                        <a:rPr lang="sv-SE" sz="1200" dirty="0" smtClean="0">
                          <a:effectLst/>
                        </a:rPr>
                        <a:t>0.01 </a:t>
                      </a:r>
                      <a:endParaRPr lang="sv-SE" sz="1200" dirty="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sv-SE" sz="1200" dirty="0" smtClean="0">
                          <a:effectLst/>
                        </a:rPr>
                        <a:t>0.05 </a:t>
                      </a:r>
                      <a:endParaRPr lang="sv-SE" sz="1200" dirty="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sv-SE" sz="1200" dirty="0" smtClean="0">
                          <a:effectLst/>
                        </a:rPr>
                        <a:t>0.30 </a:t>
                      </a:r>
                      <a:endParaRPr lang="sv-SE" sz="1200" dirty="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sv-SE" sz="1200" dirty="0" smtClean="0">
                          <a:effectLst/>
                        </a:rPr>
                        <a:t>0.10 </a:t>
                      </a:r>
                      <a:endParaRPr lang="sv-SE" sz="1200" dirty="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sv-SE" sz="120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sv-SE" sz="1200" dirty="0">
                          <a:effectLst/>
                        </a:rPr>
                        <a:t>-</a:t>
                      </a:r>
                      <a:r>
                        <a:rPr lang="sv-SE" sz="1200" dirty="0" smtClean="0">
                          <a:effectLst/>
                        </a:rPr>
                        <a:t>0.45 </a:t>
                      </a:r>
                      <a:endParaRPr lang="sv-SE" sz="1200" dirty="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sv-SE" sz="1200">
                          <a:effectLst/>
                        </a:rPr>
                        <a:t>* </a:t>
                      </a: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4882">
                <a:tc gridSpan="19">
                  <a:txBody>
                    <a:bodyPr/>
                    <a:lstStyle/>
                    <a:p>
                      <a:pPr algn="r"/>
                      <a:endParaRPr lang="sv-SE" sz="1200" dirty="0">
                        <a:effectLst/>
                      </a:endParaRP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524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</a:tr>
              <a:tr h="34882">
                <a:tc gridSpan="19">
                  <a:txBody>
                    <a:bodyPr/>
                    <a:lstStyle/>
                    <a:p>
                      <a:pPr algn="l"/>
                      <a:r>
                        <a:rPr lang="nn-NO" sz="1200" dirty="0">
                          <a:effectLst/>
                        </a:rPr>
                        <a:t>* p &lt; .05, ** p &lt; .01, *** p &lt; .001 </a:t>
                      </a:r>
                    </a:p>
                  </a:txBody>
                  <a:tcPr marL="8721" marR="8721" marT="4360" marB="4360" anchor="ctr">
                    <a:lnL>
                      <a:noFill/>
                    </a:lnL>
                    <a:lnR>
                      <a:noFill/>
                    </a:lnR>
                    <a:lnT w="1524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89027583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1</TotalTime>
  <Words>113</Words>
  <Application>Microsoft Office PowerPoint</Application>
  <PresentationFormat>Bildspel på skärmen (4:3)</PresentationFormat>
  <Paragraphs>81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Bildrubriker</vt:lpstr>
      </vt:variant>
      <vt:variant>
        <vt:i4>1</vt:i4>
      </vt:variant>
    </vt:vector>
  </HeadingPairs>
  <TitlesOfParts>
    <vt:vector size="2" baseType="lpstr">
      <vt:lpstr>Office-tema</vt:lpstr>
      <vt:lpstr>PowerPoint-presentation</vt:lpstr>
    </vt:vector>
  </TitlesOfParts>
  <Company>Uppsala universite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on</dc:title>
  <dc:creator>Leo Poom</dc:creator>
  <cp:lastModifiedBy>Leo Poom</cp:lastModifiedBy>
  <cp:revision>4</cp:revision>
  <dcterms:created xsi:type="dcterms:W3CDTF">2021-09-01T13:12:19Z</dcterms:created>
  <dcterms:modified xsi:type="dcterms:W3CDTF">2021-09-10T18:14:32Z</dcterms:modified>
</cp:coreProperties>
</file>